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8" d="100"/>
          <a:sy n="78" d="100"/>
        </p:scale>
        <p:origin x="-1504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ACFA5-BA0F-3046-A6FF-FDC6C6A7AF5A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D5D14-30CD-C84F-A233-BEBBFA21E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888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ACFA5-BA0F-3046-A6FF-FDC6C6A7AF5A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D5D14-30CD-C84F-A233-BEBBFA21E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197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ACFA5-BA0F-3046-A6FF-FDC6C6A7AF5A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D5D14-30CD-C84F-A233-BEBBFA21E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207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ACFA5-BA0F-3046-A6FF-FDC6C6A7AF5A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D5D14-30CD-C84F-A233-BEBBFA21E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431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ACFA5-BA0F-3046-A6FF-FDC6C6A7AF5A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D5D14-30CD-C84F-A233-BEBBFA21E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6851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ACFA5-BA0F-3046-A6FF-FDC6C6A7AF5A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D5D14-30CD-C84F-A233-BEBBFA21E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785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ACFA5-BA0F-3046-A6FF-FDC6C6A7AF5A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D5D14-30CD-C84F-A233-BEBBFA21E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939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ACFA5-BA0F-3046-A6FF-FDC6C6A7AF5A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D5D14-30CD-C84F-A233-BEBBFA21E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747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ACFA5-BA0F-3046-A6FF-FDC6C6A7AF5A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D5D14-30CD-C84F-A233-BEBBFA21E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228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ACFA5-BA0F-3046-A6FF-FDC6C6A7AF5A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D5D14-30CD-C84F-A233-BEBBFA21E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7776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ACFA5-BA0F-3046-A6FF-FDC6C6A7AF5A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D5D14-30CD-C84F-A233-BEBBFA21E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720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CACFA5-BA0F-3046-A6FF-FDC6C6A7AF5A}" type="datetimeFigureOut">
              <a:rPr lang="en-US" smtClean="0"/>
              <a:t>17-02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ED5D14-30CD-C84F-A233-BEBBFA21EA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955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microsoft.com/office/2007/relationships/hdphoto" Target="../media/hdphoto1.wdp"/><Relationship Id="rId5" Type="http://schemas.openxmlformats.org/officeDocument/2006/relationships/image" Target="../media/image3.tiff"/><Relationship Id="rId6" Type="http://schemas.openxmlformats.org/officeDocument/2006/relationships/image" Target="../media/image4.jpeg"/><Relationship Id="rId7" Type="http://schemas.microsoft.com/office/2007/relationships/hdphoto" Target="../media/hdphoto2.wdp"/><Relationship Id="rId8" Type="http://schemas.openxmlformats.org/officeDocument/2006/relationships/image" Target="../media/image5.tiff"/><Relationship Id="rId9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4" Type="http://schemas.openxmlformats.org/officeDocument/2006/relationships/image" Target="../media/image9.tiff"/><Relationship Id="rId5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tiff"/><Relationship Id="rId3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91450" y="606037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ig 7A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6" name="Picture 5" descr="7A Cyt p65.tif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81307" y="5948216"/>
            <a:ext cx="1249680" cy="2072640"/>
          </a:xfrm>
          <a:prstGeom prst="rect">
            <a:avLst/>
          </a:prstGeom>
        </p:spPr>
      </p:pic>
      <p:pic>
        <p:nvPicPr>
          <p:cNvPr id="7" name="Picture 6" descr="7A Cyt pY-STAT3.tif"/>
          <p:cNvPicPr>
            <a:picLocks noChangeAspect="1"/>
          </p:cNvPicPr>
          <p:nvPr/>
        </p:nvPicPr>
        <p:blipFill>
          <a:blip r:embed="rId3" cstate="screen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81307" y="1479553"/>
            <a:ext cx="1249680" cy="2072640"/>
          </a:xfrm>
          <a:prstGeom prst="rect">
            <a:avLst/>
          </a:prstGeom>
        </p:spPr>
      </p:pic>
      <p:pic>
        <p:nvPicPr>
          <p:cNvPr id="8" name="Picture 7" descr="7A Cyt STAT3.tif"/>
          <p:cNvPicPr>
            <a:picLocks noChangeAspect="1"/>
          </p:cNvPicPr>
          <p:nvPr/>
        </p:nvPicPr>
        <p:blipFill rotWithShape="1">
          <a:blip r:embed="rId5" cstate="screen">
            <a:grayscl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81307" y="3831440"/>
            <a:ext cx="1249680" cy="1979064"/>
          </a:xfrm>
          <a:prstGeom prst="rect">
            <a:avLst/>
          </a:prstGeom>
        </p:spPr>
      </p:pic>
      <p:pic>
        <p:nvPicPr>
          <p:cNvPr id="9" name="Picture 8" descr="7A Nuc pY-STAT3.tif"/>
          <p:cNvPicPr>
            <a:picLocks noChangeAspect="1"/>
          </p:cNvPicPr>
          <p:nvPr/>
        </p:nvPicPr>
        <p:blipFill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229324" y="1479553"/>
            <a:ext cx="1249680" cy="2072640"/>
          </a:xfrm>
          <a:prstGeom prst="rect">
            <a:avLst/>
          </a:prstGeom>
        </p:spPr>
      </p:pic>
      <p:pic>
        <p:nvPicPr>
          <p:cNvPr id="10" name="Picture 9" descr="7A Nuc STAT3.tif"/>
          <p:cNvPicPr>
            <a:picLocks noChangeAspect="1"/>
          </p:cNvPicPr>
          <p:nvPr/>
        </p:nvPicPr>
        <p:blipFill rotWithShape="1">
          <a:blip r:embed="rId8" cstate="screen">
            <a:grayscl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29324" y="3831440"/>
            <a:ext cx="1249680" cy="1979064"/>
          </a:xfrm>
          <a:prstGeom prst="rect">
            <a:avLst/>
          </a:prstGeom>
        </p:spPr>
      </p:pic>
      <p:pic>
        <p:nvPicPr>
          <p:cNvPr id="11" name="Picture 10" descr="7A Nuc p65.tif"/>
          <p:cNvPicPr>
            <a:picLocks noChangeAspect="1"/>
          </p:cNvPicPr>
          <p:nvPr/>
        </p:nvPicPr>
        <p:blipFill>
          <a:blip r:embed="rId9" cstate="screen">
            <a:grayscl/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229324" y="5948216"/>
            <a:ext cx="1249680" cy="207264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454019" y="4564609"/>
            <a:ext cx="8299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STAT3</a:t>
            </a:r>
            <a:r>
              <a:rPr lang="en-US" sz="1400" dirty="0" smtClean="0">
                <a:latin typeface="Symbol" charset="2"/>
                <a:cs typeface="Symbol" charset="2"/>
              </a:rPr>
              <a:t>a</a:t>
            </a:r>
            <a:endParaRPr lang="en-US" sz="1400" dirty="0">
              <a:latin typeface="Symbol" charset="2"/>
              <a:cs typeface="Symbol" charset="2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229324" y="4556497"/>
            <a:ext cx="1249681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1304376" y="2295107"/>
            <a:ext cx="9796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pY-STAT3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2229324" y="2268370"/>
            <a:ext cx="1249680" cy="43492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3681307" y="2230765"/>
            <a:ext cx="1249680" cy="434929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3681307" y="4527582"/>
            <a:ext cx="1249680" cy="38183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2496697" y="1081271"/>
            <a:ext cx="714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>
                <a:latin typeface="Arial"/>
                <a:cs typeface="Arial"/>
              </a:rPr>
              <a:t>Nuclear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794792" y="1081271"/>
            <a:ext cx="1022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>
                <a:latin typeface="Arial"/>
                <a:cs typeface="Arial"/>
              </a:rPr>
              <a:t>Cytoplasmic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799766" y="6859244"/>
            <a:ext cx="484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/>
                <a:cs typeface="Arial"/>
              </a:rPr>
              <a:t>p65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2229324" y="6851132"/>
            <a:ext cx="1249681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3681307" y="6869583"/>
            <a:ext cx="1249680" cy="287098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1111339" y="2977046"/>
            <a:ext cx="1172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Heavy chain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11339" y="5054499"/>
            <a:ext cx="1172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Heavy chain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111339" y="7115088"/>
            <a:ext cx="1172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Heavy chain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934202" y="2359805"/>
            <a:ext cx="5768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79, 86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950774" y="4578783"/>
            <a:ext cx="3415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86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964142" y="6905411"/>
            <a:ext cx="3415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55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855833" y="1231822"/>
            <a:ext cx="87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MW (</a:t>
            </a:r>
            <a:r>
              <a:rPr lang="en-US" sz="1200" dirty="0" err="1" smtClean="0">
                <a:latin typeface="Arial"/>
                <a:cs typeface="Arial"/>
              </a:rPr>
              <a:t>kDa</a:t>
            </a:r>
            <a:r>
              <a:rPr lang="en-US" sz="1200" dirty="0" smtClean="0">
                <a:latin typeface="Arial"/>
                <a:cs typeface="Arial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614991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7B 58 Stat3.tif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23629" y="1416576"/>
            <a:ext cx="1979998" cy="1714085"/>
          </a:xfrm>
          <a:prstGeom prst="rect">
            <a:avLst/>
          </a:prstGeom>
        </p:spPr>
      </p:pic>
      <p:pic>
        <p:nvPicPr>
          <p:cNvPr id="12" name="Picture 11" descr="7B 58 pY-Stat3.tif"/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35701" y="1416576"/>
            <a:ext cx="1971218" cy="171408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94916" y="480119"/>
            <a:ext cx="890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ig 7B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3" name="Picture 2" descr="7B Nuc p65.tif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77706" y="4123322"/>
            <a:ext cx="2102358" cy="1846326"/>
          </a:xfrm>
          <a:prstGeom prst="rect">
            <a:avLst/>
          </a:prstGeom>
        </p:spPr>
      </p:pic>
      <p:pic>
        <p:nvPicPr>
          <p:cNvPr id="4" name="Picture 3" descr="7B Nuc Actin.tif"/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25853" y="4149637"/>
            <a:ext cx="2102358" cy="182001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26440" y="1881133"/>
            <a:ext cx="8092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 smtClean="0">
                <a:latin typeface="Arial"/>
                <a:cs typeface="Arial"/>
              </a:rPr>
              <a:t>pY-STAT3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08902" y="4915172"/>
            <a:ext cx="8169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 smtClean="0">
                <a:latin typeface="Symbol" charset="2"/>
                <a:cs typeface="Symbol" charset="2"/>
              </a:rPr>
              <a:t>b</a:t>
            </a:r>
            <a:r>
              <a:rPr lang="en-US" sz="1100" dirty="0" smtClean="0">
                <a:latin typeface="Arial"/>
                <a:cs typeface="Arial"/>
              </a:rPr>
              <a:t>-actin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548681" y="1918355"/>
            <a:ext cx="6026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 smtClean="0">
                <a:latin typeface="Arial"/>
                <a:cs typeface="Arial"/>
              </a:rPr>
              <a:t>STAT3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039922" y="1796069"/>
            <a:ext cx="1966997" cy="396647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10" name="Rectangle 9"/>
          <p:cNvSpPr/>
          <p:nvPr/>
        </p:nvSpPr>
        <p:spPr>
          <a:xfrm>
            <a:off x="1035701" y="4865198"/>
            <a:ext cx="2092510" cy="361558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11" name="Rectangle 10"/>
          <p:cNvSpPr/>
          <p:nvPr/>
        </p:nvSpPr>
        <p:spPr>
          <a:xfrm>
            <a:off x="4123628" y="1879613"/>
            <a:ext cx="1976717" cy="339094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25" name="TextBox 24"/>
          <p:cNvSpPr txBox="1"/>
          <p:nvPr/>
        </p:nvSpPr>
        <p:spPr>
          <a:xfrm>
            <a:off x="2954011" y="1881133"/>
            <a:ext cx="5768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79, 86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6087059" y="1918355"/>
            <a:ext cx="5768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79, 86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25134" y="4915172"/>
            <a:ext cx="3415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42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671913" y="4546905"/>
            <a:ext cx="4200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 smtClean="0">
                <a:latin typeface="Arial"/>
                <a:cs typeface="Arial"/>
              </a:rPr>
              <a:t>p65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187011" y="4546905"/>
            <a:ext cx="3415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65</a:t>
            </a:r>
          </a:p>
        </p:txBody>
      </p:sp>
      <p:sp>
        <p:nvSpPr>
          <p:cNvPr id="35" name="Rectangle 34"/>
          <p:cNvSpPr/>
          <p:nvPr/>
        </p:nvSpPr>
        <p:spPr>
          <a:xfrm>
            <a:off x="4077705" y="4546905"/>
            <a:ext cx="2102359" cy="311584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32" name="TextBox 31"/>
          <p:cNvSpPr txBox="1"/>
          <p:nvPr/>
        </p:nvSpPr>
        <p:spPr>
          <a:xfrm>
            <a:off x="2921900" y="1124773"/>
            <a:ext cx="87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MW (</a:t>
            </a:r>
            <a:r>
              <a:rPr lang="en-US" sz="1200" dirty="0" err="1" smtClean="0">
                <a:latin typeface="Arial"/>
                <a:cs typeface="Arial"/>
              </a:rPr>
              <a:t>kDa</a:t>
            </a:r>
            <a:r>
              <a:rPr lang="en-US" sz="1200" dirty="0" smtClean="0">
                <a:latin typeface="Arial"/>
                <a:cs typeface="Arial"/>
              </a:rPr>
              <a:t>)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6013763" y="1146750"/>
            <a:ext cx="87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MW (</a:t>
            </a:r>
            <a:r>
              <a:rPr lang="en-US" sz="1200" dirty="0" err="1" smtClean="0">
                <a:latin typeface="Arial"/>
                <a:cs typeface="Arial"/>
              </a:rPr>
              <a:t>kDa</a:t>
            </a:r>
            <a:r>
              <a:rPr lang="en-US" sz="1200" dirty="0" smtClean="0">
                <a:latin typeface="Arial"/>
                <a:cs typeface="Arial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8801375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 descr="7C iNOS.tif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79293" y="4045458"/>
            <a:ext cx="931164" cy="2196084"/>
          </a:xfrm>
          <a:prstGeom prst="rect">
            <a:avLst/>
          </a:prstGeom>
        </p:spPr>
      </p:pic>
      <p:pic>
        <p:nvPicPr>
          <p:cNvPr id="16" name="Picture 15" descr="7C Tubulin.tif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53885" y="889706"/>
            <a:ext cx="931164" cy="219608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795123" y="570231"/>
            <a:ext cx="890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ig 7C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497528" y="4240011"/>
            <a:ext cx="5216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 err="1" smtClean="0">
                <a:latin typeface="Arial"/>
                <a:cs typeface="Arial"/>
              </a:rPr>
              <a:t>iNOS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981367" y="4258201"/>
            <a:ext cx="931165" cy="22523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3912532" y="4232317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13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234645" y="4841605"/>
            <a:ext cx="7845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 smtClean="0">
                <a:latin typeface="Symbol" charset="2"/>
                <a:cs typeface="Symbol" charset="2"/>
              </a:rPr>
              <a:t>a</a:t>
            </a:r>
            <a:r>
              <a:rPr lang="en-US" sz="1100" dirty="0" smtClean="0">
                <a:latin typeface="Arial"/>
                <a:cs typeface="Arial"/>
              </a:rPr>
              <a:t>-Tubulin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552356" y="5300898"/>
            <a:ext cx="4668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 err="1" smtClean="0">
                <a:latin typeface="Arial"/>
                <a:cs typeface="Arial"/>
              </a:rPr>
              <a:t>HuR</a:t>
            </a:r>
            <a:endParaRPr lang="en-US" sz="1100" dirty="0" smtClean="0">
              <a:latin typeface="Arial"/>
              <a:cs typeface="Arial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2952803" y="1663748"/>
            <a:ext cx="931164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1962904" y="1671860"/>
            <a:ext cx="9895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Symbol" charset="2"/>
                <a:cs typeface="Symbol" charset="2"/>
              </a:rPr>
              <a:t>a</a:t>
            </a:r>
            <a:r>
              <a:rPr lang="en-US" sz="1400" dirty="0" smtClean="0">
                <a:latin typeface="Arial"/>
                <a:cs typeface="Arial"/>
              </a:rPr>
              <a:t>-Tubulin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907230" y="168724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55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408658" y="2165329"/>
            <a:ext cx="5438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err="1" smtClean="0">
                <a:latin typeface="Arial"/>
                <a:cs typeface="Arial"/>
              </a:rPr>
              <a:t>HuR</a:t>
            </a:r>
            <a:endParaRPr lang="en-US" sz="1400" dirty="0" smtClean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353954" y="4953973"/>
            <a:ext cx="1490085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Arial"/>
                <a:cs typeface="Arial"/>
              </a:rPr>
              <a:t>Arrows indicate non-specific bands from </a:t>
            </a:r>
            <a:r>
              <a:rPr lang="en-US" sz="1050" dirty="0" err="1" smtClean="0">
                <a:latin typeface="Arial"/>
                <a:cs typeface="Arial"/>
              </a:rPr>
              <a:t>iNOS</a:t>
            </a:r>
            <a:r>
              <a:rPr lang="en-US" sz="1050" dirty="0" smtClean="0">
                <a:latin typeface="Arial"/>
                <a:cs typeface="Arial"/>
              </a:rPr>
              <a:t> antibody</a:t>
            </a:r>
            <a:endParaRPr lang="en-US" sz="1050" dirty="0">
              <a:latin typeface="Arial"/>
              <a:cs typeface="Arial"/>
            </a:endParaRPr>
          </a:p>
        </p:txBody>
      </p:sp>
      <p:sp>
        <p:nvSpPr>
          <p:cNvPr id="28" name="Right Brace 27"/>
          <p:cNvSpPr/>
          <p:nvPr/>
        </p:nvSpPr>
        <p:spPr>
          <a:xfrm>
            <a:off x="4249073" y="4471105"/>
            <a:ext cx="102973" cy="1586833"/>
          </a:xfrm>
          <a:prstGeom prst="rightBrac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2" name="Straight Arrow Connector 31"/>
          <p:cNvCxnSpPr/>
          <p:nvPr/>
        </p:nvCxnSpPr>
        <p:spPr>
          <a:xfrm flipH="1">
            <a:off x="3964424" y="4523046"/>
            <a:ext cx="215999" cy="0"/>
          </a:xfrm>
          <a:prstGeom prst="straightConnector1">
            <a:avLst/>
          </a:prstGeom>
          <a:ln>
            <a:solidFill>
              <a:srgbClr val="000000"/>
            </a:solidFill>
            <a:headEnd type="none"/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 flipH="1">
            <a:off x="3964424" y="4821010"/>
            <a:ext cx="215999" cy="0"/>
          </a:xfrm>
          <a:prstGeom prst="straightConnector1">
            <a:avLst/>
          </a:prstGeom>
          <a:ln>
            <a:solidFill>
              <a:srgbClr val="000000"/>
            </a:solidFill>
            <a:headEnd type="none"/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 flipH="1">
            <a:off x="3964424" y="5171203"/>
            <a:ext cx="215999" cy="0"/>
          </a:xfrm>
          <a:prstGeom prst="straightConnector1">
            <a:avLst/>
          </a:prstGeom>
          <a:ln>
            <a:solidFill>
              <a:srgbClr val="000000"/>
            </a:solidFill>
            <a:headEnd type="none"/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 flipH="1">
            <a:off x="3964424" y="5821878"/>
            <a:ext cx="215999" cy="0"/>
          </a:xfrm>
          <a:prstGeom prst="straightConnector1">
            <a:avLst/>
          </a:prstGeom>
          <a:ln>
            <a:solidFill>
              <a:srgbClr val="000000"/>
            </a:solidFill>
            <a:headEnd type="none"/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 flipH="1">
            <a:off x="3964424" y="6007230"/>
            <a:ext cx="215999" cy="0"/>
          </a:xfrm>
          <a:prstGeom prst="straightConnector1">
            <a:avLst/>
          </a:prstGeom>
          <a:ln>
            <a:solidFill>
              <a:srgbClr val="000000"/>
            </a:solidFill>
            <a:headEnd type="none"/>
            <a:tailEnd type="triangle" w="lg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3907230" y="2167296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32</a:t>
            </a:r>
          </a:p>
        </p:txBody>
      </p:sp>
      <p:sp>
        <p:nvSpPr>
          <p:cNvPr id="29" name="Rectangle 28"/>
          <p:cNvSpPr/>
          <p:nvPr/>
        </p:nvSpPr>
        <p:spPr>
          <a:xfrm>
            <a:off x="2952803" y="2167296"/>
            <a:ext cx="931164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2981367" y="5321429"/>
            <a:ext cx="931164" cy="324000"/>
          </a:xfrm>
          <a:prstGeom prst="rect">
            <a:avLst/>
          </a:prstGeom>
          <a:noFill/>
          <a:ln w="28575" cmpd="sng"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7001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</Words>
  <Application>Microsoft Macintosh PowerPoint</Application>
  <PresentationFormat>Letter Paper (8.5x11 in)</PresentationFormat>
  <Paragraphs>34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Ma</dc:creator>
  <cp:lastModifiedBy>Jennifer Ma</cp:lastModifiedBy>
  <cp:revision>1</cp:revision>
  <dcterms:created xsi:type="dcterms:W3CDTF">2017-02-06T17:07:30Z</dcterms:created>
  <dcterms:modified xsi:type="dcterms:W3CDTF">2017-02-06T17:07:58Z</dcterms:modified>
</cp:coreProperties>
</file>